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29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A4DB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442"/>
    <p:restoredTop sz="96327"/>
  </p:normalViewPr>
  <p:slideViewPr>
    <p:cSldViewPr snapToGrid="0">
      <p:cViewPr>
        <p:scale>
          <a:sx n="123" d="100"/>
          <a:sy n="123" d="100"/>
        </p:scale>
        <p:origin x="227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anpan li" userId="b69fa5992e0560d8" providerId="LiveId" clId="{9DE1597A-A659-7F48-B046-16A12329F4D1}"/>
    <pc:docChg chg="undo custSel delSld modSld">
      <pc:chgData name="panpan li" userId="b69fa5992e0560d8" providerId="LiveId" clId="{9DE1597A-A659-7F48-B046-16A12329F4D1}" dt="2024-03-02T18:09:59.297" v="104" actId="2696"/>
      <pc:docMkLst>
        <pc:docMk/>
      </pc:docMkLst>
      <pc:sldChg chg="del">
        <pc:chgData name="panpan li" userId="b69fa5992e0560d8" providerId="LiveId" clId="{9DE1597A-A659-7F48-B046-16A12329F4D1}" dt="2024-03-02T18:09:59.297" v="104" actId="2696"/>
        <pc:sldMkLst>
          <pc:docMk/>
          <pc:sldMk cId="3531061042" sldId="291"/>
        </pc:sldMkLst>
      </pc:sldChg>
      <pc:sldChg chg="addSp delSp modSp mod">
        <pc:chgData name="panpan li" userId="b69fa5992e0560d8" providerId="LiveId" clId="{9DE1597A-A659-7F48-B046-16A12329F4D1}" dt="2024-03-02T18:06:22.150" v="102" actId="478"/>
        <pc:sldMkLst>
          <pc:docMk/>
          <pc:sldMk cId="2848266697" sldId="293"/>
        </pc:sldMkLst>
        <pc:spChg chg="del">
          <ac:chgData name="panpan li" userId="b69fa5992e0560d8" providerId="LiveId" clId="{9DE1597A-A659-7F48-B046-16A12329F4D1}" dt="2024-03-02T18:05:19.016" v="75" actId="478"/>
          <ac:spMkLst>
            <pc:docMk/>
            <pc:sldMk cId="2848266697" sldId="293"/>
            <ac:spMk id="2" creationId="{83EBF9A0-3572-2E45-C6D8-AA7399710F2E}"/>
          </ac:spMkLst>
        </pc:spChg>
        <pc:spChg chg="del mod topLvl">
          <ac:chgData name="panpan li" userId="b69fa5992e0560d8" providerId="LiveId" clId="{9DE1597A-A659-7F48-B046-16A12329F4D1}" dt="2024-03-02T18:06:22.150" v="102" actId="478"/>
          <ac:spMkLst>
            <pc:docMk/>
            <pc:sldMk cId="2848266697" sldId="293"/>
            <ac:spMk id="5" creationId="{020D8B23-7346-F3DF-6E32-AECC47310C5F}"/>
          </ac:spMkLst>
        </pc:spChg>
        <pc:spChg chg="add del mod">
          <ac:chgData name="panpan li" userId="b69fa5992e0560d8" providerId="LiveId" clId="{9DE1597A-A659-7F48-B046-16A12329F4D1}" dt="2024-03-02T18:03:51.642" v="27" actId="478"/>
          <ac:spMkLst>
            <pc:docMk/>
            <pc:sldMk cId="2848266697" sldId="293"/>
            <ac:spMk id="7" creationId="{2D9A012E-B355-0340-D4FA-A336B5790AE1}"/>
          </ac:spMkLst>
        </pc:spChg>
        <pc:spChg chg="del">
          <ac:chgData name="panpan li" userId="b69fa5992e0560d8" providerId="LiveId" clId="{9DE1597A-A659-7F48-B046-16A12329F4D1}" dt="2024-03-02T18:03:27.978" v="13" actId="478"/>
          <ac:spMkLst>
            <pc:docMk/>
            <pc:sldMk cId="2848266697" sldId="293"/>
            <ac:spMk id="13" creationId="{551CFBB4-C499-8FE9-1B83-C0FF97DEE589}"/>
          </ac:spMkLst>
        </pc:spChg>
        <pc:spChg chg="del">
          <ac:chgData name="panpan li" userId="b69fa5992e0560d8" providerId="LiveId" clId="{9DE1597A-A659-7F48-B046-16A12329F4D1}" dt="2024-03-02T18:03:21.240" v="10" actId="478"/>
          <ac:spMkLst>
            <pc:docMk/>
            <pc:sldMk cId="2848266697" sldId="293"/>
            <ac:spMk id="14" creationId="{EC84EF25-B432-6A8A-33C2-C38A49268CE1}"/>
          </ac:spMkLst>
        </pc:spChg>
        <pc:spChg chg="del">
          <ac:chgData name="panpan li" userId="b69fa5992e0560d8" providerId="LiveId" clId="{9DE1597A-A659-7F48-B046-16A12329F4D1}" dt="2024-03-02T18:03:27.160" v="12" actId="478"/>
          <ac:spMkLst>
            <pc:docMk/>
            <pc:sldMk cId="2848266697" sldId="293"/>
            <ac:spMk id="15" creationId="{565E87C3-8D8D-529D-43E7-B2CAF2394D8B}"/>
          </ac:spMkLst>
        </pc:spChg>
        <pc:spChg chg="del">
          <ac:chgData name="panpan li" userId="b69fa5992e0560d8" providerId="LiveId" clId="{9DE1597A-A659-7F48-B046-16A12329F4D1}" dt="2024-03-02T18:03:30.222" v="14" actId="478"/>
          <ac:spMkLst>
            <pc:docMk/>
            <pc:sldMk cId="2848266697" sldId="293"/>
            <ac:spMk id="16" creationId="{FAE51BDF-67D7-4D3F-387E-1DD106F46860}"/>
          </ac:spMkLst>
        </pc:spChg>
        <pc:spChg chg="del">
          <ac:chgData name="panpan li" userId="b69fa5992e0560d8" providerId="LiveId" clId="{9DE1597A-A659-7F48-B046-16A12329F4D1}" dt="2024-03-02T18:03:31.635" v="15" actId="478"/>
          <ac:spMkLst>
            <pc:docMk/>
            <pc:sldMk cId="2848266697" sldId="293"/>
            <ac:spMk id="17" creationId="{97970438-D9F9-0295-77DF-26F10F758F90}"/>
          </ac:spMkLst>
        </pc:spChg>
        <pc:spChg chg="del">
          <ac:chgData name="panpan li" userId="b69fa5992e0560d8" providerId="LiveId" clId="{9DE1597A-A659-7F48-B046-16A12329F4D1}" dt="2024-03-02T18:03:34.645" v="17" actId="478"/>
          <ac:spMkLst>
            <pc:docMk/>
            <pc:sldMk cId="2848266697" sldId="293"/>
            <ac:spMk id="18" creationId="{F477F827-15F6-F022-A86E-AB4EC4FCC5E1}"/>
          </ac:spMkLst>
        </pc:spChg>
        <pc:spChg chg="del">
          <ac:chgData name="panpan li" userId="b69fa5992e0560d8" providerId="LiveId" clId="{9DE1597A-A659-7F48-B046-16A12329F4D1}" dt="2024-03-02T18:03:46.675" v="25" actId="478"/>
          <ac:spMkLst>
            <pc:docMk/>
            <pc:sldMk cId="2848266697" sldId="293"/>
            <ac:spMk id="19" creationId="{DD862191-6268-6D19-F146-8FA35905DF55}"/>
          </ac:spMkLst>
        </pc:spChg>
        <pc:spChg chg="del">
          <ac:chgData name="panpan li" userId="b69fa5992e0560d8" providerId="LiveId" clId="{9DE1597A-A659-7F48-B046-16A12329F4D1}" dt="2024-03-02T18:03:46.675" v="25" actId="478"/>
          <ac:spMkLst>
            <pc:docMk/>
            <pc:sldMk cId="2848266697" sldId="293"/>
            <ac:spMk id="20" creationId="{8029E889-C68B-D39B-D014-71452C36FB32}"/>
          </ac:spMkLst>
        </pc:spChg>
        <pc:spChg chg="del">
          <ac:chgData name="panpan li" userId="b69fa5992e0560d8" providerId="LiveId" clId="{9DE1597A-A659-7F48-B046-16A12329F4D1}" dt="2024-03-02T18:03:46.675" v="25" actId="478"/>
          <ac:spMkLst>
            <pc:docMk/>
            <pc:sldMk cId="2848266697" sldId="293"/>
            <ac:spMk id="21" creationId="{506233A0-A2AE-2BA7-5BFC-683C4B0C745B}"/>
          </ac:spMkLst>
        </pc:spChg>
        <pc:spChg chg="del">
          <ac:chgData name="panpan li" userId="b69fa5992e0560d8" providerId="LiveId" clId="{9DE1597A-A659-7F48-B046-16A12329F4D1}" dt="2024-03-02T18:03:46.675" v="25" actId="478"/>
          <ac:spMkLst>
            <pc:docMk/>
            <pc:sldMk cId="2848266697" sldId="293"/>
            <ac:spMk id="22" creationId="{9EE9FA93-2871-AEF9-081F-374A51686532}"/>
          </ac:spMkLst>
        </pc:spChg>
        <pc:spChg chg="del">
          <ac:chgData name="panpan li" userId="b69fa5992e0560d8" providerId="LiveId" clId="{9DE1597A-A659-7F48-B046-16A12329F4D1}" dt="2024-03-02T18:03:51.642" v="27" actId="478"/>
          <ac:spMkLst>
            <pc:docMk/>
            <pc:sldMk cId="2848266697" sldId="293"/>
            <ac:spMk id="23" creationId="{97A28EAB-DB9B-95CE-0215-7B33CBA8E7DA}"/>
          </ac:spMkLst>
        </pc:spChg>
        <pc:spChg chg="del">
          <ac:chgData name="panpan li" userId="b69fa5992e0560d8" providerId="LiveId" clId="{9DE1597A-A659-7F48-B046-16A12329F4D1}" dt="2024-03-02T18:03:51.642" v="27" actId="478"/>
          <ac:spMkLst>
            <pc:docMk/>
            <pc:sldMk cId="2848266697" sldId="293"/>
            <ac:spMk id="24" creationId="{3D2E3DD9-16A6-786D-7AFD-83E53259EAA8}"/>
          </ac:spMkLst>
        </pc:spChg>
        <pc:spChg chg="del">
          <ac:chgData name="panpan li" userId="b69fa5992e0560d8" providerId="LiveId" clId="{9DE1597A-A659-7F48-B046-16A12329F4D1}" dt="2024-03-02T18:03:51.642" v="27" actId="478"/>
          <ac:spMkLst>
            <pc:docMk/>
            <pc:sldMk cId="2848266697" sldId="293"/>
            <ac:spMk id="25" creationId="{E0AEFF25-7909-1C60-D98C-189614974800}"/>
          </ac:spMkLst>
        </pc:spChg>
        <pc:spChg chg="del">
          <ac:chgData name="panpan li" userId="b69fa5992e0560d8" providerId="LiveId" clId="{9DE1597A-A659-7F48-B046-16A12329F4D1}" dt="2024-03-02T18:03:51.642" v="27" actId="478"/>
          <ac:spMkLst>
            <pc:docMk/>
            <pc:sldMk cId="2848266697" sldId="293"/>
            <ac:spMk id="26" creationId="{BB03CFDC-352D-2803-F9F7-C110A0FF1B18}"/>
          </ac:spMkLst>
        </pc:spChg>
        <pc:spChg chg="del">
          <ac:chgData name="panpan li" userId="b69fa5992e0560d8" providerId="LiveId" clId="{9DE1597A-A659-7F48-B046-16A12329F4D1}" dt="2024-03-02T18:03:51.642" v="27" actId="478"/>
          <ac:spMkLst>
            <pc:docMk/>
            <pc:sldMk cId="2848266697" sldId="293"/>
            <ac:spMk id="27" creationId="{3AB12DAB-91BF-4707-2974-DC5597DEBE3B}"/>
          </ac:spMkLst>
        </pc:spChg>
        <pc:spChg chg="del">
          <ac:chgData name="panpan li" userId="b69fa5992e0560d8" providerId="LiveId" clId="{9DE1597A-A659-7F48-B046-16A12329F4D1}" dt="2024-03-02T18:03:46.675" v="25" actId="478"/>
          <ac:spMkLst>
            <pc:docMk/>
            <pc:sldMk cId="2848266697" sldId="293"/>
            <ac:spMk id="28" creationId="{6023A181-7D9F-7A83-3063-11E2A8B11433}"/>
          </ac:spMkLst>
        </pc:spChg>
        <pc:spChg chg="del">
          <ac:chgData name="panpan li" userId="b69fa5992e0560d8" providerId="LiveId" clId="{9DE1597A-A659-7F48-B046-16A12329F4D1}" dt="2024-03-02T18:03:46.675" v="25" actId="478"/>
          <ac:spMkLst>
            <pc:docMk/>
            <pc:sldMk cId="2848266697" sldId="293"/>
            <ac:spMk id="29" creationId="{B6DBAA4B-9FE1-0162-102F-0ED2136E129F}"/>
          </ac:spMkLst>
        </pc:spChg>
        <pc:spChg chg="del">
          <ac:chgData name="panpan li" userId="b69fa5992e0560d8" providerId="LiveId" clId="{9DE1597A-A659-7F48-B046-16A12329F4D1}" dt="2024-03-02T18:03:46.675" v="25" actId="478"/>
          <ac:spMkLst>
            <pc:docMk/>
            <pc:sldMk cId="2848266697" sldId="293"/>
            <ac:spMk id="30" creationId="{862AB1E3-0EA0-303F-3AC8-89998F67A98A}"/>
          </ac:spMkLst>
        </pc:spChg>
        <pc:spChg chg="del">
          <ac:chgData name="panpan li" userId="b69fa5992e0560d8" providerId="LiveId" clId="{9DE1597A-A659-7F48-B046-16A12329F4D1}" dt="2024-03-02T18:03:46.675" v="25" actId="478"/>
          <ac:spMkLst>
            <pc:docMk/>
            <pc:sldMk cId="2848266697" sldId="293"/>
            <ac:spMk id="31" creationId="{44C08FDE-87F5-7BAF-AD7C-966FE041A91A}"/>
          </ac:spMkLst>
        </pc:spChg>
        <pc:spChg chg="del">
          <ac:chgData name="panpan li" userId="b69fa5992e0560d8" providerId="LiveId" clId="{9DE1597A-A659-7F48-B046-16A12329F4D1}" dt="2024-03-02T18:03:46.675" v="25" actId="478"/>
          <ac:spMkLst>
            <pc:docMk/>
            <pc:sldMk cId="2848266697" sldId="293"/>
            <ac:spMk id="32" creationId="{96AFC22D-A3BD-E7C6-5592-8D3B55A6FDD7}"/>
          </ac:spMkLst>
        </pc:spChg>
        <pc:spChg chg="mod">
          <ac:chgData name="panpan li" userId="b69fa5992e0560d8" providerId="LiveId" clId="{9DE1597A-A659-7F48-B046-16A12329F4D1}" dt="2024-03-02T18:06:19.277" v="101" actId="20577"/>
          <ac:spMkLst>
            <pc:docMk/>
            <pc:sldMk cId="2848266697" sldId="293"/>
            <ac:spMk id="248" creationId="{C54C1FC3-D060-3CE8-6DE6-16DC87BC5B5F}"/>
          </ac:spMkLst>
        </pc:spChg>
        <pc:spChg chg="del">
          <ac:chgData name="panpan li" userId="b69fa5992e0560d8" providerId="LiveId" clId="{9DE1597A-A659-7F48-B046-16A12329F4D1}" dt="2024-02-28T10:46:11.968" v="2" actId="478"/>
          <ac:spMkLst>
            <pc:docMk/>
            <pc:sldMk cId="2848266697" sldId="293"/>
            <ac:spMk id="254" creationId="{73F712AC-1B73-A9C0-DE99-9C7883CEF9A3}"/>
          </ac:spMkLst>
        </pc:spChg>
        <pc:grpChg chg="add del mod">
          <ac:chgData name="panpan li" userId="b69fa5992e0560d8" providerId="LiveId" clId="{9DE1597A-A659-7F48-B046-16A12329F4D1}" dt="2024-03-02T18:03:43.796" v="24" actId="165"/>
          <ac:grpSpMkLst>
            <pc:docMk/>
            <pc:sldMk cId="2848266697" sldId="293"/>
            <ac:grpSpMk id="3" creationId="{E8A6E40D-A8AF-B304-9332-5527A1719F92}"/>
          </ac:grpSpMkLst>
        </pc:grpChg>
        <pc:grpChg chg="del">
          <ac:chgData name="panpan li" userId="b69fa5992e0560d8" providerId="LiveId" clId="{9DE1597A-A659-7F48-B046-16A12329F4D1}" dt="2024-02-28T10:46:09.968" v="1" actId="478"/>
          <ac:grpSpMkLst>
            <pc:docMk/>
            <pc:sldMk cId="2848266697" sldId="293"/>
            <ac:grpSpMk id="12" creationId="{222D4924-18AD-456F-8631-021B2656E660}"/>
          </ac:grpSpMkLst>
        </pc:grpChg>
        <pc:picChg chg="del">
          <ac:chgData name="panpan li" userId="b69fa5992e0560d8" providerId="LiveId" clId="{9DE1597A-A659-7F48-B046-16A12329F4D1}" dt="2024-03-02T18:03:40.653" v="23" actId="478"/>
          <ac:picMkLst>
            <pc:docMk/>
            <pc:sldMk cId="2848266697" sldId="293"/>
            <ac:picMk id="4" creationId="{BBE7DFBA-2576-E6EB-802C-2D706117038C}"/>
          </ac:picMkLst>
        </pc:picChg>
        <pc:picChg chg="del topLvl">
          <ac:chgData name="panpan li" userId="b69fa5992e0560d8" providerId="LiveId" clId="{9DE1597A-A659-7F48-B046-16A12329F4D1}" dt="2024-03-02T18:03:48.141" v="26" actId="478"/>
          <ac:picMkLst>
            <pc:docMk/>
            <pc:sldMk cId="2848266697" sldId="293"/>
            <ac:picMk id="6" creationId="{129165BD-78F2-4F30-1A50-902F5E20F78B}"/>
          </ac:picMkLst>
        </pc:picChg>
        <pc:picChg chg="del topLvl">
          <ac:chgData name="panpan li" userId="b69fa5992e0560d8" providerId="LiveId" clId="{9DE1597A-A659-7F48-B046-16A12329F4D1}" dt="2024-03-02T18:03:46.675" v="25" actId="478"/>
          <ac:picMkLst>
            <pc:docMk/>
            <pc:sldMk cId="2848266697" sldId="293"/>
            <ac:picMk id="8" creationId="{9E372ACD-BE49-4C75-6C72-03A513990568}"/>
          </ac:picMkLst>
        </pc:picChg>
        <pc:picChg chg="del topLvl">
          <ac:chgData name="panpan li" userId="b69fa5992e0560d8" providerId="LiveId" clId="{9DE1597A-A659-7F48-B046-16A12329F4D1}" dt="2024-03-02T18:03:46.675" v="25" actId="478"/>
          <ac:picMkLst>
            <pc:docMk/>
            <pc:sldMk cId="2848266697" sldId="293"/>
            <ac:picMk id="10" creationId="{88169635-DBC6-2AC3-22B6-109F046B4962}"/>
          </ac:picMkLst>
        </pc:picChg>
        <pc:picChg chg="add mod">
          <ac:chgData name="panpan li" userId="b69fa5992e0560d8" providerId="LiveId" clId="{9DE1597A-A659-7F48-B046-16A12329F4D1}" dt="2024-03-02T18:05:16.471" v="74" actId="1076"/>
          <ac:picMkLst>
            <pc:docMk/>
            <pc:sldMk cId="2848266697" sldId="293"/>
            <ac:picMk id="11" creationId="{3B586FCA-DAF1-07C5-5793-E1F16BB3AB6C}"/>
          </ac:picMkLst>
        </pc:picChg>
        <pc:picChg chg="del">
          <ac:chgData name="panpan li" userId="b69fa5992e0560d8" providerId="LiveId" clId="{9DE1597A-A659-7F48-B046-16A12329F4D1}" dt="2024-03-02T18:03:11.853" v="6" actId="478"/>
          <ac:picMkLst>
            <pc:docMk/>
            <pc:sldMk cId="2848266697" sldId="293"/>
            <ac:picMk id="39" creationId="{80E6EBE7-2AE1-B6B6-8FDB-9F4C6D2C0301}"/>
          </ac:picMkLst>
        </pc:picChg>
        <pc:picChg chg="del">
          <ac:chgData name="panpan li" userId="b69fa5992e0560d8" providerId="LiveId" clId="{9DE1597A-A659-7F48-B046-16A12329F4D1}" dt="2024-03-02T18:03:10.237" v="4" actId="478"/>
          <ac:picMkLst>
            <pc:docMk/>
            <pc:sldMk cId="2848266697" sldId="293"/>
            <ac:picMk id="41" creationId="{7FD9CB9A-E9EB-3BE4-066E-C22FE0F9A4EE}"/>
          </ac:picMkLst>
        </pc:picChg>
        <pc:picChg chg="del">
          <ac:chgData name="panpan li" userId="b69fa5992e0560d8" providerId="LiveId" clId="{9DE1597A-A659-7F48-B046-16A12329F4D1}" dt="2024-03-02T18:03:18.707" v="9" actId="478"/>
          <ac:picMkLst>
            <pc:docMk/>
            <pc:sldMk cId="2848266697" sldId="293"/>
            <ac:picMk id="43" creationId="{D7B05534-52B4-7E01-0BD7-5D3498E69892}"/>
          </ac:picMkLst>
        </pc:picChg>
        <pc:picChg chg="del">
          <ac:chgData name="panpan li" userId="b69fa5992e0560d8" providerId="LiveId" clId="{9DE1597A-A659-7F48-B046-16A12329F4D1}" dt="2024-03-02T18:03:25.748" v="11" actId="478"/>
          <ac:picMkLst>
            <pc:docMk/>
            <pc:sldMk cId="2848266697" sldId="293"/>
            <ac:picMk id="45" creationId="{A1812717-EECA-E1E7-986D-A24DFB7013D1}"/>
          </ac:picMkLst>
        </pc:picChg>
      </pc:sldChg>
      <pc:sldChg chg="delSp del mod">
        <pc:chgData name="panpan li" userId="b69fa5992e0560d8" providerId="LiveId" clId="{9DE1597A-A659-7F48-B046-16A12329F4D1}" dt="2024-03-02T18:09:49.442" v="103" actId="2696"/>
        <pc:sldMkLst>
          <pc:docMk/>
          <pc:sldMk cId="1650988562" sldId="294"/>
        </pc:sldMkLst>
        <pc:spChg chg="del">
          <ac:chgData name="panpan li" userId="b69fa5992e0560d8" providerId="LiveId" clId="{9DE1597A-A659-7F48-B046-16A12329F4D1}" dt="2024-03-02T18:06:09.679" v="99" actId="478"/>
          <ac:spMkLst>
            <pc:docMk/>
            <pc:sldMk cId="1650988562" sldId="294"/>
            <ac:spMk id="163" creationId="{07CC6980-361B-A567-8740-32A6D3601905}"/>
          </ac:spMkLst>
        </pc:spChg>
        <pc:spChg chg="del">
          <ac:chgData name="panpan li" userId="b69fa5992e0560d8" providerId="LiveId" clId="{9DE1597A-A659-7F48-B046-16A12329F4D1}" dt="2024-03-02T18:06:09.679" v="99" actId="478"/>
          <ac:spMkLst>
            <pc:docMk/>
            <pc:sldMk cId="1650988562" sldId="294"/>
            <ac:spMk id="164" creationId="{3B55B806-5142-C302-5C00-3C9F5A48BB0F}"/>
          </ac:spMkLst>
        </pc:spChg>
        <pc:spChg chg="del">
          <ac:chgData name="panpan li" userId="b69fa5992e0560d8" providerId="LiveId" clId="{9DE1597A-A659-7F48-B046-16A12329F4D1}" dt="2024-03-02T18:06:09.679" v="99" actId="478"/>
          <ac:spMkLst>
            <pc:docMk/>
            <pc:sldMk cId="1650988562" sldId="294"/>
            <ac:spMk id="165" creationId="{F3A80779-4FB3-990C-7E3F-ADDEAC2A4A9F}"/>
          </ac:spMkLst>
        </pc:spChg>
        <pc:spChg chg="del">
          <ac:chgData name="panpan li" userId="b69fa5992e0560d8" providerId="LiveId" clId="{9DE1597A-A659-7F48-B046-16A12329F4D1}" dt="2024-03-02T18:06:09.679" v="99" actId="478"/>
          <ac:spMkLst>
            <pc:docMk/>
            <pc:sldMk cId="1650988562" sldId="294"/>
            <ac:spMk id="166" creationId="{EC2CCCA2-E07B-FF08-6004-7E9791BD4391}"/>
          </ac:spMkLst>
        </pc:spChg>
        <pc:grpChg chg="del">
          <ac:chgData name="panpan li" userId="b69fa5992e0560d8" providerId="LiveId" clId="{9DE1597A-A659-7F48-B046-16A12329F4D1}" dt="2024-03-02T18:06:09.679" v="99" actId="478"/>
          <ac:grpSpMkLst>
            <pc:docMk/>
            <pc:sldMk cId="1650988562" sldId="294"/>
            <ac:grpSpMk id="4" creationId="{19D3641F-D14A-0B04-BEAA-586EEC04C240}"/>
          </ac:grpSpMkLst>
        </pc:grpChg>
        <pc:grpChg chg="del">
          <ac:chgData name="panpan li" userId="b69fa5992e0560d8" providerId="LiveId" clId="{9DE1597A-A659-7F48-B046-16A12329F4D1}" dt="2024-03-02T18:06:09.679" v="99" actId="478"/>
          <ac:grpSpMkLst>
            <pc:docMk/>
            <pc:sldMk cId="1650988562" sldId="294"/>
            <ac:grpSpMk id="159" creationId="{37DE2BB8-9460-1B5F-7F5B-62D2CA56730A}"/>
          </ac:grpSpMkLst>
        </pc:grpChg>
      </pc:sldChg>
    </pc:docChg>
  </pc:docChgLst>
  <pc:docChgLst>
    <pc:chgData name="Li Panpan" userId="60ca6675-9ecc-4a4e-ad09-dbd58d4bd42c" providerId="ADAL" clId="{01FAB03D-9879-4F42-9A91-C32E8C6F0F88}"/>
    <pc:docChg chg="undo custSel delSld modSld">
      <pc:chgData name="Li Panpan" userId="60ca6675-9ecc-4a4e-ad09-dbd58d4bd42c" providerId="ADAL" clId="{01FAB03D-9879-4F42-9A91-C32E8C6F0F88}" dt="2024-01-02T11:11:07.133" v="212" actId="1076"/>
      <pc:docMkLst>
        <pc:docMk/>
      </pc:docMkLst>
      <pc:sldChg chg="delSp modSp del mod">
        <pc:chgData name="Li Panpan" userId="60ca6675-9ecc-4a4e-ad09-dbd58d4bd42c" providerId="ADAL" clId="{01FAB03D-9879-4F42-9A91-C32E8C6F0F88}" dt="2024-01-02T11:09:35.987" v="194" actId="2696"/>
        <pc:sldMkLst>
          <pc:docMk/>
          <pc:sldMk cId="2492095121" sldId="292"/>
        </pc:sldMkLst>
        <pc:spChg chg="mod">
          <ac:chgData name="Li Panpan" userId="60ca6675-9ecc-4a4e-ad09-dbd58d4bd42c" providerId="ADAL" clId="{01FAB03D-9879-4F42-9A91-C32E8C6F0F88}" dt="2024-01-02T11:09:10.478" v="189" actId="21"/>
          <ac:spMkLst>
            <pc:docMk/>
            <pc:sldMk cId="2492095121" sldId="292"/>
            <ac:spMk id="287" creationId="{2E186DFB-38B0-A4EC-60A4-2E906D80CB26}"/>
          </ac:spMkLst>
        </pc:spChg>
        <pc:grpChg chg="del">
          <ac:chgData name="Li Panpan" userId="60ca6675-9ecc-4a4e-ad09-dbd58d4bd42c" providerId="ADAL" clId="{01FAB03D-9879-4F42-9A91-C32E8C6F0F88}" dt="2024-01-02T11:07:49.326" v="164" actId="21"/>
          <ac:grpSpMkLst>
            <pc:docMk/>
            <pc:sldMk cId="2492095121" sldId="292"/>
            <ac:grpSpMk id="2" creationId="{DD42CDF8-19B2-C81C-FD81-ABC954614F76}"/>
          </ac:grpSpMkLst>
        </pc:grpChg>
      </pc:sldChg>
      <pc:sldChg chg="addSp delSp modSp mod">
        <pc:chgData name="Li Panpan" userId="60ca6675-9ecc-4a4e-ad09-dbd58d4bd42c" providerId="ADAL" clId="{01FAB03D-9879-4F42-9A91-C32E8C6F0F88}" dt="2024-01-02T11:11:07.133" v="212" actId="1076"/>
        <pc:sldMkLst>
          <pc:docMk/>
          <pc:sldMk cId="2848266697" sldId="293"/>
        </pc:sldMkLst>
        <pc:spChg chg="add mod">
          <ac:chgData name="Li Panpan" userId="60ca6675-9ecc-4a4e-ad09-dbd58d4bd42c" providerId="ADAL" clId="{01FAB03D-9879-4F42-9A91-C32E8C6F0F88}" dt="2024-01-02T11:08:48.449" v="184" actId="1076"/>
          <ac:spMkLst>
            <pc:docMk/>
            <pc:sldMk cId="2848266697" sldId="293"/>
            <ac:spMk id="2" creationId="{83EBF9A0-3572-2E45-C6D8-AA7399710F2E}"/>
          </ac:spMkLst>
        </pc:spChg>
        <pc:spChg chg="mod">
          <ac:chgData name="Li Panpan" userId="60ca6675-9ecc-4a4e-ad09-dbd58d4bd42c" providerId="ADAL" clId="{01FAB03D-9879-4F42-9A91-C32E8C6F0F88}" dt="2024-01-02T11:08:52.540" v="185" actId="1076"/>
          <ac:spMkLst>
            <pc:docMk/>
            <pc:sldMk cId="2848266697" sldId="293"/>
            <ac:spMk id="5" creationId="{020D8B23-7346-F3DF-6E32-AECC47310C5F}"/>
          </ac:spMkLst>
        </pc:spChg>
        <pc:spChg chg="del">
          <ac:chgData name="Li Panpan" userId="60ca6675-9ecc-4a4e-ad09-dbd58d4bd42c" providerId="ADAL" clId="{01FAB03D-9879-4F42-9A91-C32E8C6F0F88}" dt="2024-01-02T11:01:50.603" v="4" actId="478"/>
          <ac:spMkLst>
            <pc:docMk/>
            <pc:sldMk cId="2848266697" sldId="293"/>
            <ac:spMk id="7" creationId="{9B808E6D-2465-7EE6-762C-EE89C36FE35A}"/>
          </ac:spMkLst>
        </pc:spChg>
        <pc:spChg chg="del">
          <ac:chgData name="Li Panpan" userId="60ca6675-9ecc-4a4e-ad09-dbd58d4bd42c" providerId="ADAL" clId="{01FAB03D-9879-4F42-9A91-C32E8C6F0F88}" dt="2024-01-02T11:01:52.560" v="5" actId="478"/>
          <ac:spMkLst>
            <pc:docMk/>
            <pc:sldMk cId="2848266697" sldId="293"/>
            <ac:spMk id="9" creationId="{1EEFFF21-2D15-79C2-1CE8-8E5B5D60CBDA}"/>
          </ac:spMkLst>
        </pc:spChg>
        <pc:spChg chg="del">
          <ac:chgData name="Li Panpan" userId="60ca6675-9ecc-4a4e-ad09-dbd58d4bd42c" providerId="ADAL" clId="{01FAB03D-9879-4F42-9A91-C32E8C6F0F88}" dt="2024-01-02T11:01:54.342" v="6" actId="478"/>
          <ac:spMkLst>
            <pc:docMk/>
            <pc:sldMk cId="2848266697" sldId="293"/>
            <ac:spMk id="11" creationId="{7228B4AC-DF94-51D5-13C9-AAFF843CC6C3}"/>
          </ac:spMkLst>
        </pc:spChg>
        <pc:spChg chg="del">
          <ac:chgData name="Li Panpan" userId="60ca6675-9ecc-4a4e-ad09-dbd58d4bd42c" providerId="ADAL" clId="{01FAB03D-9879-4F42-9A91-C32E8C6F0F88}" dt="2024-01-02T11:00:36.280" v="1" actId="478"/>
          <ac:spMkLst>
            <pc:docMk/>
            <pc:sldMk cId="2848266697" sldId="293"/>
            <ac:spMk id="34" creationId="{880D5609-23A9-9FC2-B8C9-796CAD488772}"/>
          </ac:spMkLst>
        </pc:spChg>
        <pc:spChg chg="del">
          <ac:chgData name="Li Panpan" userId="60ca6675-9ecc-4a4e-ad09-dbd58d4bd42c" providerId="ADAL" clId="{01FAB03D-9879-4F42-9A91-C32E8C6F0F88}" dt="2024-01-02T11:00:36.280" v="1" actId="478"/>
          <ac:spMkLst>
            <pc:docMk/>
            <pc:sldMk cId="2848266697" sldId="293"/>
            <ac:spMk id="36" creationId="{DD39F5A3-1339-AC7E-D03A-7F4BD477C979}"/>
          </ac:spMkLst>
        </pc:spChg>
        <pc:spChg chg="del">
          <ac:chgData name="Li Panpan" userId="60ca6675-9ecc-4a4e-ad09-dbd58d4bd42c" providerId="ADAL" clId="{01FAB03D-9879-4F42-9A91-C32E8C6F0F88}" dt="2024-01-02T11:00:36.280" v="1" actId="478"/>
          <ac:spMkLst>
            <pc:docMk/>
            <pc:sldMk cId="2848266697" sldId="293"/>
            <ac:spMk id="38" creationId="{1D895C33-15FF-CBFB-47F3-1FA79B6F400E}"/>
          </ac:spMkLst>
        </pc:spChg>
        <pc:spChg chg="del">
          <ac:chgData name="Li Panpan" userId="60ca6675-9ecc-4a4e-ad09-dbd58d4bd42c" providerId="ADAL" clId="{01FAB03D-9879-4F42-9A91-C32E8C6F0F88}" dt="2024-01-02T11:02:00.114" v="9" actId="478"/>
          <ac:spMkLst>
            <pc:docMk/>
            <pc:sldMk cId="2848266697" sldId="293"/>
            <ac:spMk id="40" creationId="{287EC175-9966-9D49-D508-5B7C5B88061A}"/>
          </ac:spMkLst>
        </pc:spChg>
        <pc:spChg chg="del">
          <ac:chgData name="Li Panpan" userId="60ca6675-9ecc-4a4e-ad09-dbd58d4bd42c" providerId="ADAL" clId="{01FAB03D-9879-4F42-9A91-C32E8C6F0F88}" dt="2024-01-02T11:02:01.724" v="10" actId="478"/>
          <ac:spMkLst>
            <pc:docMk/>
            <pc:sldMk cId="2848266697" sldId="293"/>
            <ac:spMk id="42" creationId="{E0FA3DC0-94F4-D316-5FBC-D370E325C6D5}"/>
          </ac:spMkLst>
        </pc:spChg>
        <pc:spChg chg="del">
          <ac:chgData name="Li Panpan" userId="60ca6675-9ecc-4a4e-ad09-dbd58d4bd42c" providerId="ADAL" clId="{01FAB03D-9879-4F42-9A91-C32E8C6F0F88}" dt="2024-01-02T11:01:57.984" v="8" actId="478"/>
          <ac:spMkLst>
            <pc:docMk/>
            <pc:sldMk cId="2848266697" sldId="293"/>
            <ac:spMk id="44" creationId="{7D19C56A-8CCE-23DE-9D9B-C675E8985AA6}"/>
          </ac:spMkLst>
        </pc:spChg>
        <pc:spChg chg="del">
          <ac:chgData name="Li Panpan" userId="60ca6675-9ecc-4a4e-ad09-dbd58d4bd42c" providerId="ADAL" clId="{01FAB03D-9879-4F42-9A91-C32E8C6F0F88}" dt="2024-01-02T11:01:56.527" v="7" actId="478"/>
          <ac:spMkLst>
            <pc:docMk/>
            <pc:sldMk cId="2848266697" sldId="293"/>
            <ac:spMk id="46" creationId="{F3B088CC-E1D0-BE37-E319-439CA97D0030}"/>
          </ac:spMkLst>
        </pc:spChg>
        <pc:spChg chg="del mod">
          <ac:chgData name="Li Panpan" userId="60ca6675-9ecc-4a4e-ad09-dbd58d4bd42c" providerId="ADAL" clId="{01FAB03D-9879-4F42-9A91-C32E8C6F0F88}" dt="2024-01-02T11:08:26.655" v="178" actId="478"/>
          <ac:spMkLst>
            <pc:docMk/>
            <pc:sldMk cId="2848266697" sldId="293"/>
            <ac:spMk id="246" creationId="{E5FFDBE5-7E2D-FC5B-EED0-3AE7F660D932}"/>
          </ac:spMkLst>
        </pc:spChg>
        <pc:spChg chg="mod">
          <ac:chgData name="Li Panpan" userId="60ca6675-9ecc-4a4e-ad09-dbd58d4bd42c" providerId="ADAL" clId="{01FAB03D-9879-4F42-9A91-C32E8C6F0F88}" dt="2024-01-02T11:11:07.133" v="212" actId="1076"/>
          <ac:spMkLst>
            <pc:docMk/>
            <pc:sldMk cId="2848266697" sldId="293"/>
            <ac:spMk id="248" creationId="{C54C1FC3-D060-3CE8-6DE6-16DC87BC5B5F}"/>
          </ac:spMkLst>
        </pc:spChg>
        <pc:spChg chg="del mod">
          <ac:chgData name="Li Panpan" userId="60ca6675-9ecc-4a4e-ad09-dbd58d4bd42c" providerId="ADAL" clId="{01FAB03D-9879-4F42-9A91-C32E8C6F0F88}" dt="2024-01-02T11:08:21.916" v="175" actId="478"/>
          <ac:spMkLst>
            <pc:docMk/>
            <pc:sldMk cId="2848266697" sldId="293"/>
            <ac:spMk id="249" creationId="{BA28FB02-9974-6930-9C3F-5F46B15946F6}"/>
          </ac:spMkLst>
        </pc:spChg>
        <pc:spChg chg="del mod">
          <ac:chgData name="Li Panpan" userId="60ca6675-9ecc-4a4e-ad09-dbd58d4bd42c" providerId="ADAL" clId="{01FAB03D-9879-4F42-9A91-C32E8C6F0F88}" dt="2024-01-02T11:08:23.555" v="176" actId="478"/>
          <ac:spMkLst>
            <pc:docMk/>
            <pc:sldMk cId="2848266697" sldId="293"/>
            <ac:spMk id="251" creationId="{9422DC26-58E3-D1C5-7E36-234B7E7F8B56}"/>
          </ac:spMkLst>
        </pc:spChg>
        <pc:spChg chg="del mod">
          <ac:chgData name="Li Panpan" userId="60ca6675-9ecc-4a4e-ad09-dbd58d4bd42c" providerId="ADAL" clId="{01FAB03D-9879-4F42-9A91-C32E8C6F0F88}" dt="2024-01-02T11:08:25.045" v="177" actId="478"/>
          <ac:spMkLst>
            <pc:docMk/>
            <pc:sldMk cId="2848266697" sldId="293"/>
            <ac:spMk id="253" creationId="{4A9C5775-4D10-2E38-1A70-99E44E30E60E}"/>
          </ac:spMkLst>
        </pc:spChg>
        <pc:spChg chg="add mod">
          <ac:chgData name="Li Panpan" userId="60ca6675-9ecc-4a4e-ad09-dbd58d4bd42c" providerId="ADAL" clId="{01FAB03D-9879-4F42-9A91-C32E8C6F0F88}" dt="2024-01-02T11:08:43.994" v="183" actId="20577"/>
          <ac:spMkLst>
            <pc:docMk/>
            <pc:sldMk cId="2848266697" sldId="293"/>
            <ac:spMk id="254" creationId="{73F712AC-1B73-A9C0-DE99-9C7883CEF9A3}"/>
          </ac:spMkLst>
        </pc:spChg>
        <pc:grpChg chg="mod">
          <ac:chgData name="Li Panpan" userId="60ca6675-9ecc-4a4e-ad09-dbd58d4bd42c" providerId="ADAL" clId="{01FAB03D-9879-4F42-9A91-C32E8C6F0F88}" dt="2024-01-02T11:02:18.344" v="14" actId="1076"/>
          <ac:grpSpMkLst>
            <pc:docMk/>
            <pc:sldMk cId="2848266697" sldId="293"/>
            <ac:grpSpMk id="3" creationId="{E8A6E40D-A8AF-B304-9332-5527A1719F92}"/>
          </ac:grpSpMkLst>
        </pc:grpChg>
        <pc:grpChg chg="add mod">
          <ac:chgData name="Li Panpan" userId="60ca6675-9ecc-4a4e-ad09-dbd58d4bd42c" providerId="ADAL" clId="{01FAB03D-9879-4F42-9A91-C32E8C6F0F88}" dt="2024-01-02T11:08:28.956" v="180" actId="1037"/>
          <ac:grpSpMkLst>
            <pc:docMk/>
            <pc:sldMk cId="2848266697" sldId="293"/>
            <ac:grpSpMk id="12" creationId="{222D4924-18AD-456F-8631-021B2656E660}"/>
          </ac:grpSpMkLst>
        </pc:grpChg>
        <pc:grpChg chg="del">
          <ac:chgData name="Li Panpan" userId="60ca6675-9ecc-4a4e-ad09-dbd58d4bd42c" providerId="ADAL" clId="{01FAB03D-9879-4F42-9A91-C32E8C6F0F88}" dt="2024-01-02T10:59:54.338" v="0" actId="478"/>
          <ac:grpSpMkLst>
            <pc:docMk/>
            <pc:sldMk cId="2848266697" sldId="293"/>
            <ac:grpSpMk id="47" creationId="{8DA39FA4-A0AC-DBED-C53C-75CF94B666AB}"/>
          </ac:grpSpMkLst>
        </pc:grpChg>
        <pc:picChg chg="del">
          <ac:chgData name="Li Panpan" userId="60ca6675-9ecc-4a4e-ad09-dbd58d4bd42c" providerId="ADAL" clId="{01FAB03D-9879-4F42-9A91-C32E8C6F0F88}" dt="2024-01-02T11:00:36.280" v="1" actId="478"/>
          <ac:picMkLst>
            <pc:docMk/>
            <pc:sldMk cId="2848266697" sldId="293"/>
            <ac:picMk id="33" creationId="{8CFE850C-8154-1F78-4B61-25F54A982A42}"/>
          </ac:picMkLst>
        </pc:picChg>
        <pc:picChg chg="del">
          <ac:chgData name="Li Panpan" userId="60ca6675-9ecc-4a4e-ad09-dbd58d4bd42c" providerId="ADAL" clId="{01FAB03D-9879-4F42-9A91-C32E8C6F0F88}" dt="2024-01-02T11:00:36.280" v="1" actId="478"/>
          <ac:picMkLst>
            <pc:docMk/>
            <pc:sldMk cId="2848266697" sldId="293"/>
            <ac:picMk id="35" creationId="{A17D3508-1161-F1DD-537F-E917388532A7}"/>
          </ac:picMkLst>
        </pc:picChg>
        <pc:picChg chg="del">
          <ac:chgData name="Li Panpan" userId="60ca6675-9ecc-4a4e-ad09-dbd58d4bd42c" providerId="ADAL" clId="{01FAB03D-9879-4F42-9A91-C32E8C6F0F88}" dt="2024-01-02T11:00:36.280" v="1" actId="478"/>
          <ac:picMkLst>
            <pc:docMk/>
            <pc:sldMk cId="2848266697" sldId="293"/>
            <ac:picMk id="37" creationId="{638CF4C2-BEF8-9114-E846-F1399591BD80}"/>
          </ac:picMkLst>
        </pc:picChg>
        <pc:picChg chg="mod">
          <ac:chgData name="Li Panpan" userId="60ca6675-9ecc-4a4e-ad09-dbd58d4bd42c" providerId="ADAL" clId="{01FAB03D-9879-4F42-9A91-C32E8C6F0F88}" dt="2024-01-02T11:07:53.104" v="166"/>
          <ac:picMkLst>
            <pc:docMk/>
            <pc:sldMk cId="2848266697" sldId="293"/>
            <ac:picMk id="245" creationId="{539F6DA3-E679-3E31-11BF-177DB9E7ABAB}"/>
          </ac:picMkLst>
        </pc:picChg>
        <pc:picChg chg="mod">
          <ac:chgData name="Li Panpan" userId="60ca6675-9ecc-4a4e-ad09-dbd58d4bd42c" providerId="ADAL" clId="{01FAB03D-9879-4F42-9A91-C32E8C6F0F88}" dt="2024-01-02T11:07:53.104" v="166"/>
          <ac:picMkLst>
            <pc:docMk/>
            <pc:sldMk cId="2848266697" sldId="293"/>
            <ac:picMk id="247" creationId="{A1BFF4BA-6DE7-AE58-BEC3-545B38E859A7}"/>
          </ac:picMkLst>
        </pc:picChg>
        <pc:picChg chg="mod">
          <ac:chgData name="Li Panpan" userId="60ca6675-9ecc-4a4e-ad09-dbd58d4bd42c" providerId="ADAL" clId="{01FAB03D-9879-4F42-9A91-C32E8C6F0F88}" dt="2024-01-02T11:07:53.104" v="166"/>
          <ac:picMkLst>
            <pc:docMk/>
            <pc:sldMk cId="2848266697" sldId="293"/>
            <ac:picMk id="250" creationId="{6CFC0564-3346-2300-2AC5-031ECA1F5A78}"/>
          </ac:picMkLst>
        </pc:picChg>
        <pc:picChg chg="mod">
          <ac:chgData name="Li Panpan" userId="60ca6675-9ecc-4a4e-ad09-dbd58d4bd42c" providerId="ADAL" clId="{01FAB03D-9879-4F42-9A91-C32E8C6F0F88}" dt="2024-01-02T11:07:53.104" v="166"/>
          <ac:picMkLst>
            <pc:docMk/>
            <pc:sldMk cId="2848266697" sldId="293"/>
            <ac:picMk id="252" creationId="{37D26E96-69F7-A0A0-E417-16A8A3D8B341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F1A90B-97CE-B348-B8B2-E76FE24FEACC}" type="datetimeFigureOut">
              <a:rPr kumimoji="1" lang="zh-CN" altLang="en-US" smtClean="0"/>
              <a:t>2024/3/2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374D41-EAFB-764C-AEF9-8E23E24731D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073526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66" indent="0" algn="ctr">
              <a:buNone/>
              <a:defRPr sz="1500"/>
            </a:lvl2pPr>
            <a:lvl3pPr marL="685732" indent="0" algn="ctr">
              <a:buNone/>
              <a:defRPr sz="1350"/>
            </a:lvl3pPr>
            <a:lvl4pPr marL="1028599" indent="0" algn="ctr">
              <a:buNone/>
              <a:defRPr sz="1200"/>
            </a:lvl4pPr>
            <a:lvl5pPr marL="1371464" indent="0" algn="ctr">
              <a:buNone/>
              <a:defRPr sz="1200"/>
            </a:lvl5pPr>
            <a:lvl6pPr marL="1714331" indent="0" algn="ctr">
              <a:buNone/>
              <a:defRPr sz="1200"/>
            </a:lvl6pPr>
            <a:lvl7pPr marL="2057197" indent="0" algn="ctr">
              <a:buNone/>
              <a:defRPr sz="1200"/>
            </a:lvl7pPr>
            <a:lvl8pPr marL="2400063" indent="0" algn="ctr">
              <a:buNone/>
              <a:defRPr sz="1200"/>
            </a:lvl8pPr>
            <a:lvl9pPr marL="2742929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B4D61-F140-A046-BF65-6494FF2566BF}" type="datetimeFigureOut">
              <a:rPr kumimoji="1" lang="zh-CN" altLang="en-US" smtClean="0"/>
              <a:t>2024/3/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6F527-E555-C345-A25F-0EE08B0FB01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750845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B4D61-F140-A046-BF65-6494FF2566BF}" type="datetimeFigureOut">
              <a:rPr kumimoji="1" lang="zh-CN" altLang="en-US" smtClean="0"/>
              <a:t>2024/3/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6F527-E555-C345-A25F-0EE08B0FB01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19625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7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7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B4D61-F140-A046-BF65-6494FF2566BF}" type="datetimeFigureOut">
              <a:rPr kumimoji="1" lang="zh-CN" altLang="en-US" smtClean="0"/>
              <a:t>2024/3/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6F527-E555-C345-A25F-0EE08B0FB01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67020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B4D61-F140-A046-BF65-6494FF2566BF}" type="datetimeFigureOut">
              <a:rPr kumimoji="1" lang="zh-CN" altLang="en-US" smtClean="0"/>
              <a:t>2024/3/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6F527-E555-C345-A25F-0EE08B0FB01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05264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30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6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3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5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6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19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06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92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B4D61-F140-A046-BF65-6494FF2566BF}" type="datetimeFigureOut">
              <a:rPr kumimoji="1" lang="zh-CN" altLang="en-US" smtClean="0"/>
              <a:t>2024/3/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6F527-E555-C345-A25F-0EE08B0FB01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886922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B4D61-F140-A046-BF65-6494FF2566BF}" type="datetimeFigureOut">
              <a:rPr kumimoji="1" lang="zh-CN" altLang="en-US" smtClean="0"/>
              <a:t>2024/3/2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6F527-E555-C345-A25F-0EE08B0FB01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24815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3" y="2428351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66" indent="0">
              <a:buNone/>
              <a:defRPr sz="1500" b="1"/>
            </a:lvl2pPr>
            <a:lvl3pPr marL="685732" indent="0">
              <a:buNone/>
              <a:defRPr sz="1350" b="1"/>
            </a:lvl3pPr>
            <a:lvl4pPr marL="1028599" indent="0">
              <a:buNone/>
              <a:defRPr sz="1200" b="1"/>
            </a:lvl4pPr>
            <a:lvl5pPr marL="1371464" indent="0">
              <a:buNone/>
              <a:defRPr sz="1200" b="1"/>
            </a:lvl5pPr>
            <a:lvl6pPr marL="1714331" indent="0">
              <a:buNone/>
              <a:defRPr sz="1200" b="1"/>
            </a:lvl6pPr>
            <a:lvl7pPr marL="2057197" indent="0">
              <a:buNone/>
              <a:defRPr sz="1200" b="1"/>
            </a:lvl7pPr>
            <a:lvl8pPr marL="2400063" indent="0">
              <a:buNone/>
              <a:defRPr sz="1200" b="1"/>
            </a:lvl8pPr>
            <a:lvl9pPr marL="2742929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3" y="3618444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5" y="2428351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66" indent="0">
              <a:buNone/>
              <a:defRPr sz="1500" b="1"/>
            </a:lvl2pPr>
            <a:lvl3pPr marL="685732" indent="0">
              <a:buNone/>
              <a:defRPr sz="1350" b="1"/>
            </a:lvl3pPr>
            <a:lvl4pPr marL="1028599" indent="0">
              <a:buNone/>
              <a:defRPr sz="1200" b="1"/>
            </a:lvl4pPr>
            <a:lvl5pPr marL="1371464" indent="0">
              <a:buNone/>
              <a:defRPr sz="1200" b="1"/>
            </a:lvl5pPr>
            <a:lvl6pPr marL="1714331" indent="0">
              <a:buNone/>
              <a:defRPr sz="1200" b="1"/>
            </a:lvl6pPr>
            <a:lvl7pPr marL="2057197" indent="0">
              <a:buNone/>
              <a:defRPr sz="1200" b="1"/>
            </a:lvl7pPr>
            <a:lvl8pPr marL="2400063" indent="0">
              <a:buNone/>
              <a:defRPr sz="1200" b="1"/>
            </a:lvl8pPr>
            <a:lvl9pPr marL="2742929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5" y="3618444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B4D61-F140-A046-BF65-6494FF2566BF}" type="datetimeFigureOut">
              <a:rPr kumimoji="1" lang="zh-CN" altLang="en-US" smtClean="0"/>
              <a:t>2024/3/2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6F527-E555-C345-A25F-0EE08B0FB01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868961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B4D61-F140-A046-BF65-6494FF2566BF}" type="datetimeFigureOut">
              <a:rPr kumimoji="1" lang="zh-CN" altLang="en-US" smtClean="0"/>
              <a:t>2024/3/2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6F527-E555-C345-A25F-0EE08B0FB01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707891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B4D61-F140-A046-BF65-6494FF2566BF}" type="datetimeFigureOut">
              <a:rPr kumimoji="1" lang="zh-CN" altLang="en-US" smtClean="0"/>
              <a:t>2024/3/2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6F527-E555-C345-A25F-0EE08B0FB01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593996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426287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4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66" indent="0">
              <a:buNone/>
              <a:defRPr sz="1050"/>
            </a:lvl2pPr>
            <a:lvl3pPr marL="685732" indent="0">
              <a:buNone/>
              <a:defRPr sz="900"/>
            </a:lvl3pPr>
            <a:lvl4pPr marL="1028599" indent="0">
              <a:buNone/>
              <a:defRPr sz="750"/>
            </a:lvl4pPr>
            <a:lvl5pPr marL="1371464" indent="0">
              <a:buNone/>
              <a:defRPr sz="750"/>
            </a:lvl5pPr>
            <a:lvl6pPr marL="1714331" indent="0">
              <a:buNone/>
              <a:defRPr sz="750"/>
            </a:lvl6pPr>
            <a:lvl7pPr marL="2057197" indent="0">
              <a:buNone/>
              <a:defRPr sz="750"/>
            </a:lvl7pPr>
            <a:lvl8pPr marL="2400063" indent="0">
              <a:buNone/>
              <a:defRPr sz="750"/>
            </a:lvl8pPr>
            <a:lvl9pPr marL="2742929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B4D61-F140-A046-BF65-6494FF2566BF}" type="datetimeFigureOut">
              <a:rPr kumimoji="1" lang="zh-CN" altLang="en-US" smtClean="0"/>
              <a:t>2024/3/2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6F527-E555-C345-A25F-0EE08B0FB01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197504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426287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66" indent="0">
              <a:buNone/>
              <a:defRPr sz="2100"/>
            </a:lvl2pPr>
            <a:lvl3pPr marL="685732" indent="0">
              <a:buNone/>
              <a:defRPr sz="1800"/>
            </a:lvl3pPr>
            <a:lvl4pPr marL="1028599" indent="0">
              <a:buNone/>
              <a:defRPr sz="1500"/>
            </a:lvl4pPr>
            <a:lvl5pPr marL="1371464" indent="0">
              <a:buNone/>
              <a:defRPr sz="1500"/>
            </a:lvl5pPr>
            <a:lvl6pPr marL="1714331" indent="0">
              <a:buNone/>
              <a:defRPr sz="1500"/>
            </a:lvl6pPr>
            <a:lvl7pPr marL="2057197" indent="0">
              <a:buNone/>
              <a:defRPr sz="1500"/>
            </a:lvl7pPr>
            <a:lvl8pPr marL="2400063" indent="0">
              <a:buNone/>
              <a:defRPr sz="1500"/>
            </a:lvl8pPr>
            <a:lvl9pPr marL="2742929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4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66" indent="0">
              <a:buNone/>
              <a:defRPr sz="1050"/>
            </a:lvl2pPr>
            <a:lvl3pPr marL="685732" indent="0">
              <a:buNone/>
              <a:defRPr sz="900"/>
            </a:lvl3pPr>
            <a:lvl4pPr marL="1028599" indent="0">
              <a:buNone/>
              <a:defRPr sz="750"/>
            </a:lvl4pPr>
            <a:lvl5pPr marL="1371464" indent="0">
              <a:buNone/>
              <a:defRPr sz="750"/>
            </a:lvl5pPr>
            <a:lvl6pPr marL="1714331" indent="0">
              <a:buNone/>
              <a:defRPr sz="750"/>
            </a:lvl6pPr>
            <a:lvl7pPr marL="2057197" indent="0">
              <a:buNone/>
              <a:defRPr sz="750"/>
            </a:lvl7pPr>
            <a:lvl8pPr marL="2400063" indent="0">
              <a:buNone/>
              <a:defRPr sz="750"/>
            </a:lvl8pPr>
            <a:lvl9pPr marL="2742929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B4D61-F140-A046-BF65-6494FF2566BF}" type="datetimeFigureOut">
              <a:rPr kumimoji="1" lang="zh-CN" altLang="en-US" smtClean="0"/>
              <a:t>2024/3/2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6F527-E555-C345-A25F-0EE08B0FB01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86397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DB4D61-F140-A046-BF65-6494FF2566BF}" type="datetimeFigureOut">
              <a:rPr kumimoji="1" lang="zh-CN" altLang="en-US" smtClean="0"/>
              <a:t>2024/3/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9181401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B6F527-E555-C345-A25F-0EE08B0FB01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28635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73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3" indent="-171433" algn="l" defTabSz="68573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299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66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32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898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764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30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496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362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66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32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599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464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31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197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063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929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8" name="文本框 247">
            <a:extLst>
              <a:ext uri="{FF2B5EF4-FFF2-40B4-BE49-F238E27FC236}">
                <a16:creationId xmlns:a16="http://schemas.microsoft.com/office/drawing/2014/main" id="{C54C1FC3-D060-3CE8-6DE6-16DC87BC5B5F}"/>
              </a:ext>
            </a:extLst>
          </p:cNvPr>
          <p:cNvSpPr txBox="1"/>
          <p:nvPr/>
        </p:nvSpPr>
        <p:spPr>
          <a:xfrm>
            <a:off x="0" y="1836114"/>
            <a:ext cx="6493045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i="1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宋体" panose="02010600030101010101" pitchFamily="2" charset="-122"/>
              </a:rPr>
              <a:t>SI Figure 1. </a:t>
            </a:r>
            <a:r>
              <a:rPr lang="en-US" altLang="zh-CN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宋体" panose="02010600030101010101" pitchFamily="2" charset="-122"/>
              </a:rPr>
              <a:t>Analysis of DHE staining intensity in INL</a:t>
            </a:r>
            <a:r>
              <a:rPr lang="zh-CN" altLang="en-US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1200" dirty="0">
                <a:solidFill>
                  <a:srgbClr val="222222"/>
                </a:solidFill>
                <a:latin typeface="Arial" panose="020B0604020202020204" pitchFamily="34" charset="0"/>
                <a:ea typeface="DengXian" panose="02010600030101010101" pitchFamily="2" charset="-122"/>
                <a:cs typeface="宋体" panose="02010600030101010101" pitchFamily="2" charset="-122"/>
              </a:rPr>
              <a:t>and</a:t>
            </a:r>
            <a:r>
              <a:rPr lang="zh-CN" altLang="en-US" sz="1200" dirty="0">
                <a:solidFill>
                  <a:srgbClr val="222222"/>
                </a:solidFill>
                <a:latin typeface="Arial" panose="020B0604020202020204" pitchFamily="34" charset="0"/>
                <a:ea typeface="DengXian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1200" dirty="0">
                <a:solidFill>
                  <a:srgbClr val="222222"/>
                </a:solidFill>
                <a:latin typeface="Arial" panose="020B0604020202020204" pitchFamily="34" charset="0"/>
                <a:ea typeface="DengXian" panose="02010600030101010101" pitchFamily="2" charset="-122"/>
                <a:cs typeface="宋体" panose="02010600030101010101" pitchFamily="2" charset="-122"/>
              </a:rPr>
              <a:t>ONL</a:t>
            </a:r>
            <a:r>
              <a:rPr lang="zh-CN" altLang="en-US" sz="1200" dirty="0">
                <a:solidFill>
                  <a:srgbClr val="222222"/>
                </a:solidFill>
                <a:latin typeface="Arial" panose="020B0604020202020204" pitchFamily="34" charset="0"/>
                <a:ea typeface="DengXian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宋体" panose="02010600030101010101" pitchFamily="2" charset="-122"/>
              </a:rPr>
              <a:t>in WT and </a:t>
            </a:r>
            <a:r>
              <a:rPr lang="en-US" altLang="zh-CN" sz="1200" i="1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宋体" panose="02010600030101010101" pitchFamily="2" charset="-122"/>
              </a:rPr>
              <a:t>Nox2</a:t>
            </a:r>
            <a:r>
              <a:rPr lang="en-US" altLang="zh-CN" sz="1200" i="1" baseline="300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宋体" panose="02010600030101010101" pitchFamily="2" charset="-122"/>
              </a:rPr>
              <a:t>-/-</a:t>
            </a:r>
            <a:r>
              <a:rPr lang="en-US" altLang="zh-CN" sz="1200" i="1" dirty="0">
                <a:solidFill>
                  <a:srgbClr val="222222"/>
                </a:solidFill>
                <a:latin typeface="Arial" panose="020B0604020202020204" pitchFamily="34" charset="0"/>
                <a:ea typeface="DengXian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1200" dirty="0">
                <a:solidFill>
                  <a:srgbClr val="222222"/>
                </a:solidFill>
                <a:latin typeface="Arial" panose="020B0604020202020204" pitchFamily="34" charset="0"/>
                <a:ea typeface="DengXian" panose="02010600030101010101" pitchFamily="2" charset="-122"/>
                <a:cs typeface="宋体" panose="02010600030101010101" pitchFamily="2" charset="-122"/>
              </a:rPr>
              <a:t>r</a:t>
            </a:r>
            <a:r>
              <a:rPr lang="en-US" altLang="zh-CN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宋体" panose="02010600030101010101" pitchFamily="2" charset="-122"/>
              </a:rPr>
              <a:t>etinas. Data are presented as the percent fluorescence intensity of the groups versus control-Vehicle. Data are shown as mean ± SEM (n = 6 in each group, one-way ANOVA with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Tukey's multiple comparisons test</a:t>
            </a:r>
            <a:r>
              <a:rPr lang="en-US" altLang="zh-CN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宋体" panose="02010600030101010101" pitchFamily="2" charset="-122"/>
              </a:rPr>
              <a:t>, * p &lt; 0.05, ** p &lt; 0.01, *** p &lt; 0.001, ****p &lt; 0.0001).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endParaRPr lang="zh-CN" alt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3B586FCA-DAF1-07C5-5793-E1F16BB3AB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3302" y="62625"/>
            <a:ext cx="5029731" cy="17734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482666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 2013 - 2022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82879</TotalTime>
  <Words>77</Words>
  <Application>Microsoft Macintosh PowerPoint</Application>
  <PresentationFormat>A4 纸张(210x297 毫米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宋体</vt:lpstr>
      <vt:lpstr>Arial</vt:lpstr>
      <vt:lpstr>Calibri</vt:lpstr>
      <vt:lpstr>Calibri Light</vt:lpstr>
      <vt:lpstr>Office 主题​​</vt:lpstr>
      <vt:lpstr>PowerPoint 演示文稿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subject/>
  <dc:creator>Li Panpan</dc:creator>
  <cp:keywords/>
  <dc:description/>
  <cp:lastModifiedBy>panpan li</cp:lastModifiedBy>
  <cp:revision>711</cp:revision>
  <dcterms:created xsi:type="dcterms:W3CDTF">2022-10-13T10:21:00Z</dcterms:created>
  <dcterms:modified xsi:type="dcterms:W3CDTF">2024-03-02T18:10:04Z</dcterms:modified>
  <cp:category/>
</cp:coreProperties>
</file>